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46" autoAdjust="0"/>
    <p:restoredTop sz="89398" autoAdjust="0"/>
  </p:normalViewPr>
  <p:slideViewPr>
    <p:cSldViewPr snapToGrid="0">
      <p:cViewPr varScale="1">
        <p:scale>
          <a:sx n="99" d="100"/>
          <a:sy n="99" d="100"/>
        </p:scale>
        <p:origin x="153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A20B1C-9D20-44AB-B843-000CD0EA8CCC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43AF5C-E8C6-4200-B7F8-904F3615A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9760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-Figure 2 |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orrelation of </a:t>
            </a:r>
            <a:r>
              <a:rPr lang="en-US" altLang="zh-CN" sz="1200" b="1" i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SIRT2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expression and various immune cells in tumor and normal tissue of LUAD and LUSC by using </a:t>
            </a:r>
            <a:r>
              <a:rPr lang="en-US" altLang="zh-CN" sz="1200" b="1" dirty="0">
                <a:effectLst/>
                <a:latin typeface="等线" panose="02010600030101010101" pitchFamily="2" charset="-122"/>
                <a:cs typeface="Times New Roman" panose="02020603050405020304" pitchFamily="18" charset="0"/>
              </a:rPr>
              <a:t>GEPIA2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.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Markers include </a:t>
            </a:r>
            <a:r>
              <a:rPr lang="it-IT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D8A and CD8B of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D8+ T cell; </a:t>
            </a:r>
            <a:r>
              <a:rPr lang="it-IT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D3D, CD3E and CD2 of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general T cell; </a:t>
            </a:r>
            <a:r>
              <a:rPr lang="it-IT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FOXP3, CCR8, STAT5B and TGFB1 of Treg;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PDCD1, CTLA4, LAG3, HAVCR2 and GZMB of exhausted T cells; CD163, VSIG4 and MS4A4A of M2 macrophages; CD86 and CSF1R of monocytes; HLA-DPB1, HLA-DQB1, HLA-DRA, HLA-DPA1, CD1C, NRP1 and ITGAX of Dendritic cell. Scatterplots of </a:t>
            </a:r>
            <a:r>
              <a:rPr lang="en-US" altLang="zh-CN" sz="1200" b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orrelations between </a:t>
            </a:r>
            <a:r>
              <a:rPr lang="en-US" altLang="zh-CN" sz="1200" b="0" i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  <a:cs typeface="+mn-cs"/>
              </a:rPr>
              <a:t>SIRT2</a:t>
            </a:r>
            <a:r>
              <a:rPr lang="en-US" altLang="zh-CN" sz="1200" b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expression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and gene markers of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D8+ T cell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A, B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T cell (general)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(C, D), Treg (E, F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M2 Macrophage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M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N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Monocyte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O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Dendritic cell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Q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R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 in tumor and normal tissue of LUAD;  Scatterplots of correlations </a:t>
            </a:r>
            <a:r>
              <a:rPr lang="en-US" altLang="zh-CN" sz="1200" b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between </a:t>
            </a:r>
            <a:r>
              <a:rPr lang="en-US" altLang="zh-CN" sz="1200" b="0" i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  <a:cs typeface="+mn-cs"/>
              </a:rPr>
              <a:t>SIRT2</a:t>
            </a:r>
            <a:r>
              <a:rPr lang="en-US" altLang="zh-CN" sz="1200" b="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expression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and gene markers of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CD8+ T cell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G, H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 T cell (general)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I, J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, Treg (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K, L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M2 Macrophage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S, T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Monocyte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U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V), </a:t>
            </a:r>
            <a:r>
              <a:rPr lang="en-US" altLang="zh-CN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Dendritic cell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 (W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charset="0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itchFamily="2" charset="-122"/>
              </a:rPr>
              <a:t>X) in tumor and normal tissue of LUSC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3AF5C-E8C6-4200-B7F8-904F3615A6E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7044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A6BAF2-D062-4B47-A4CD-031EDD8DEF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32DD06-2D33-4B0B-9ECB-6F462DF998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BAD6A3-0D69-4C39-8E56-07907EEB8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40A9B9-4DE9-482E-8E92-B21ACCA0D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A93AD6-20B0-4D54-990A-771B6C448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5591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9C7770-9F3B-447A-9666-D7DC077BB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EDE659F-6083-4FCE-9D88-ADDD1AD193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B558B2-F16F-4905-9408-001666FD1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7FE64EF-DF3C-4F7E-ACEF-5B18981F3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094882-0752-4446-A97F-6875C1847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285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033089F-645A-4800-AF2D-561D48746E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62B230A-77EB-4859-B7BD-6602F37DBA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B0EC77-37B1-4CDB-A78F-22363207F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95E749-44ED-4C93-B909-A81A477C8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CA5E67-5BBD-4C4C-8516-F19F4D14E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1337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8FC6C7-6DE2-4C5D-8084-BA394B088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D57695A-D489-46A2-A0B0-20CEDEBAC9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AC8A76-20BD-4249-A497-E486B1EB0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048EAB-E6DF-4455-9E18-F297005D2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B1695B-A5C9-4A79-BE30-19F760D46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2307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70B5A5-01C4-4ED3-9E04-F62E3E0A54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770FCA-BB9D-4005-B7B6-7C4CCA444D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0A7BE5-2592-4294-8A07-C15671542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F00F34-F741-4CAB-A136-8583548E9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A3B551-FE4B-42FA-86C6-66B10F01D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1005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5BE47D-D79B-4906-92C7-18035649B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5F71D3-0891-4F5A-AC13-401896461D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0357F5E-3991-48CA-A162-2A2EF943F9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A58B9D-C147-49EF-8CF8-47F413C23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FA5ECE-337F-4161-AC81-B83A0839E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705A9C-37EE-4267-B99A-1E657B81F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991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D3C0D7-E233-46A7-9654-6CC1F403D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4CE938-100F-4A18-81EE-78A888162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BFCFE7-8CBE-46A8-ABD7-E9B80CCEA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37B376A-CA06-40E8-8F87-4798D0ACCF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686B746-7C87-4414-AB40-D9E110968F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752D857-E7A0-49C3-9415-D090E366C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2F70EEB-BA41-4112-950C-0B71140CB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F5F4E4E-64E9-4649-974C-6709EF945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665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0F4F40-E738-467D-9C7D-DE8BC3818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0B4933B-81F2-4D55-9316-FFAC051F8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B251F21-E7DB-4037-A005-3C4C5D981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4E38CF8-7036-4103-9C2C-27E257A55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8875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F399AF9-D507-455D-965F-5900268C4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DB0E472-2094-4C0F-BD18-536E13C94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1C5143D-B585-43B6-B9BD-73A1A21D2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508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69D441-08AE-4A25-9837-44E213F1C5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661853-E7FB-4D85-AC03-838BE7B74E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9E2346-D3FF-44C9-91BB-5F04D658F1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E7E792-DE70-4899-BE15-DE981FBAC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CE6A719-0FC1-4295-B061-14D69212C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7E6377-278D-4703-B8C2-6DD2D4BAF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975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0D73EA-D12B-4B9D-86D6-D41F436899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0978D37-63D4-4F36-A5B8-F6C53ED839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33A5454-5817-47ED-A02D-0D31103E1C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51AA991-4A6F-4E78-A79E-8D315A2E7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1A3730F-A899-48DE-AC21-71378DCEC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5404D0-64B9-46F4-8017-2FF17CA5E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85698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38AD522-4CD5-4412-87F8-8F7B88B782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10DE08-97C6-4B6D-816E-B76ED03F15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E2E56D-9C00-4AE6-9BE7-CD31309C8A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BC54A3-7E5D-47BD-B0EB-8373AD849243}" type="datetimeFigureOut">
              <a:rPr lang="zh-CN" altLang="en-US" smtClean="0"/>
              <a:t>2022/4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A29056-A085-494C-B4D6-8943525389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46B740-7AAB-47D6-AAC9-474A974CCB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FA5C9-E52A-4DFF-9D61-E3B667B286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5733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图片 86">
            <a:extLst>
              <a:ext uri="{FF2B5EF4-FFF2-40B4-BE49-F238E27FC236}">
                <a16:creationId xmlns:a16="http://schemas.microsoft.com/office/drawing/2014/main" id="{830CF167-912A-4C2A-80DD-EBC58F3A2E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3153" y="5265007"/>
            <a:ext cx="1633846" cy="1440000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681BE9FD-49D4-4F05-AA07-56503CC5BF6D}"/>
              </a:ext>
            </a:extLst>
          </p:cNvPr>
          <p:cNvSpPr txBox="1"/>
          <p:nvPr/>
        </p:nvSpPr>
        <p:spPr>
          <a:xfrm>
            <a:off x="194310" y="3497580"/>
            <a:ext cx="120202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                                                    N                                                          O                                                             P                                                        Q                                                         R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8B8F2E9-FBD3-411A-926B-B67D2BB44943}"/>
              </a:ext>
            </a:extLst>
          </p:cNvPr>
          <p:cNvSpPr txBox="1"/>
          <p:nvPr/>
        </p:nvSpPr>
        <p:spPr>
          <a:xfrm rot="16200000">
            <a:off x="-585400" y="887900"/>
            <a:ext cx="1360359" cy="177473"/>
          </a:xfrm>
          <a:prstGeom prst="rect">
            <a:avLst/>
          </a:prstGeom>
          <a:noFill/>
        </p:spPr>
        <p:txBody>
          <a:bodyPr wrap="square">
            <a:noAutofit/>
          </a:bodyPr>
          <a:lstStyle>
            <a:defPPr>
              <a:defRPr lang="en-US"/>
            </a:defPPr>
            <a:lvl1pPr>
              <a:defRPr sz="900" b="1" kern="0">
                <a:latin typeface="Times New Roman" panose="02020603050405020304" pitchFamily="18" charset="0"/>
                <a:ea typeface="宋体" pitchFamily="2" charset="-122"/>
              </a:defRPr>
            </a:lvl1pPr>
          </a:lstStyle>
          <a:p>
            <a:pPr algn="ctr"/>
            <a:r>
              <a:rPr lang="en-US" altLang="zh-CN" dirty="0"/>
              <a:t>LUAD</a:t>
            </a:r>
            <a:endParaRPr lang="zh-CN" altLang="en-US" dirty="0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D75E95D-1855-4140-B760-2E1026D96028}"/>
              </a:ext>
            </a:extLst>
          </p:cNvPr>
          <p:cNvSpPr/>
          <p:nvPr/>
        </p:nvSpPr>
        <p:spPr>
          <a:xfrm>
            <a:off x="357809" y="0"/>
            <a:ext cx="331391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+ T cell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2C24914E-5022-4C2E-AE45-CA54B4A26F46}"/>
              </a:ext>
            </a:extLst>
          </p:cNvPr>
          <p:cNvSpPr/>
          <p:nvPr/>
        </p:nvSpPr>
        <p:spPr>
          <a:xfrm>
            <a:off x="3923803" y="0"/>
            <a:ext cx="320935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 (general)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ACCA3221-18AB-4B53-805A-4A5A2609C8EE}"/>
              </a:ext>
            </a:extLst>
          </p:cNvPr>
          <p:cNvSpPr/>
          <p:nvPr/>
        </p:nvSpPr>
        <p:spPr>
          <a:xfrm>
            <a:off x="7199837" y="0"/>
            <a:ext cx="338746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g 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49B90C8-116A-45AA-BE40-F9303A899346}"/>
              </a:ext>
            </a:extLst>
          </p:cNvPr>
          <p:cNvSpPr txBox="1"/>
          <p:nvPr/>
        </p:nvSpPr>
        <p:spPr>
          <a:xfrm>
            <a:off x="848995" y="3495579"/>
            <a:ext cx="112668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                                             Normal                                                   Tumor                                                Normal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    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                                                 Normal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312CBC6-7F6C-4936-8C8C-968CA730D1A6}"/>
              </a:ext>
            </a:extLst>
          </p:cNvPr>
          <p:cNvSpPr txBox="1"/>
          <p:nvPr/>
        </p:nvSpPr>
        <p:spPr>
          <a:xfrm rot="16200000">
            <a:off x="-534606" y="4217791"/>
            <a:ext cx="1283789" cy="199998"/>
          </a:xfrm>
          <a:prstGeom prst="rect">
            <a:avLst/>
          </a:prstGeom>
          <a:noFill/>
        </p:spPr>
        <p:txBody>
          <a:bodyPr wrap="square">
            <a:noAutofit/>
          </a:bodyPr>
          <a:lstStyle>
            <a:defPPr>
              <a:defRPr lang="en-US"/>
            </a:defPPr>
            <a:lvl1pPr>
              <a:defRPr sz="900" b="1" kern="0">
                <a:latin typeface="Times New Roman" panose="02020603050405020304" pitchFamily="18" charset="0"/>
                <a:ea typeface="宋体" pitchFamily="2" charset="-122"/>
              </a:defRPr>
            </a:lvl1pPr>
          </a:lstStyle>
          <a:p>
            <a:pPr algn="ctr"/>
            <a:r>
              <a:rPr lang="en-US" altLang="zh-CN" dirty="0"/>
              <a:t>LUAD</a:t>
            </a:r>
            <a:endParaRPr lang="zh-CN" altLang="en-US" dirty="0"/>
          </a:p>
        </p:txBody>
      </p: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9D1BC075-B93E-4B6A-9C3B-86DB84E54C05}"/>
              </a:ext>
            </a:extLst>
          </p:cNvPr>
          <p:cNvGrpSpPr/>
          <p:nvPr/>
        </p:nvGrpSpPr>
        <p:grpSpPr>
          <a:xfrm>
            <a:off x="176780" y="141826"/>
            <a:ext cx="10410522" cy="236105"/>
            <a:chOff x="176780" y="189451"/>
            <a:chExt cx="10410522" cy="236105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BA4B49D-3B87-4A57-8883-B182F61ADCD8}"/>
                </a:ext>
              </a:extLst>
            </p:cNvPr>
            <p:cNvSpPr txBox="1"/>
            <p:nvPr/>
          </p:nvSpPr>
          <p:spPr>
            <a:xfrm>
              <a:off x="176780" y="194724"/>
              <a:ext cx="1041052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                                                          B                                                        C                                                            D                                                      E                                                             F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4D5FFA9-5905-48CA-B326-02F0FD36B1BE}"/>
                </a:ext>
              </a:extLst>
            </p:cNvPr>
            <p:cNvSpPr txBox="1"/>
            <p:nvPr/>
          </p:nvSpPr>
          <p:spPr>
            <a:xfrm>
              <a:off x="898854" y="189451"/>
              <a:ext cx="96884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                                                 Normal                                                 Tumor                                              Normal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                    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                                             Normal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矩形 18">
            <a:extLst>
              <a:ext uri="{FF2B5EF4-FFF2-40B4-BE49-F238E27FC236}">
                <a16:creationId xmlns:a16="http://schemas.microsoft.com/office/drawing/2014/main" id="{A2EDEEEC-6655-49F8-8F57-7B5C80FB03CE}"/>
              </a:ext>
            </a:extLst>
          </p:cNvPr>
          <p:cNvSpPr/>
          <p:nvPr/>
        </p:nvSpPr>
        <p:spPr>
          <a:xfrm>
            <a:off x="1330024" y="1755590"/>
            <a:ext cx="6579870" cy="103505"/>
          </a:xfrm>
          <a:prstGeom prst="rect">
            <a:avLst/>
          </a:prstGeom>
          <a:solidFill>
            <a:srgbClr val="FFFFFF">
              <a:alpha val="100000"/>
            </a:srgbClr>
          </a:solidFill>
          <a:ln w="12700" cmpd="sng">
            <a:noFill/>
            <a:prstDash val="solid"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zh-CN" altLang="en-US" sz="900">
              <a:solidFill>
                <a:srgbClr val="000000"/>
              </a:solidFill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8E23548-EAFE-483E-A0E6-51E5A7FAFE32}"/>
              </a:ext>
            </a:extLst>
          </p:cNvPr>
          <p:cNvSpPr txBox="1"/>
          <p:nvPr/>
        </p:nvSpPr>
        <p:spPr>
          <a:xfrm rot="16200000">
            <a:off x="-565296" y="2439274"/>
            <a:ext cx="1360357" cy="199997"/>
          </a:xfrm>
          <a:prstGeom prst="rect">
            <a:avLst/>
          </a:prstGeom>
          <a:noFill/>
        </p:spPr>
        <p:txBody>
          <a:bodyPr wrap="square">
            <a:noAutofit/>
          </a:bodyPr>
          <a:lstStyle>
            <a:defPPr>
              <a:defRPr lang="en-US"/>
            </a:defPPr>
            <a:lvl1pPr>
              <a:defRPr sz="900" b="1" kern="0">
                <a:latin typeface="Times New Roman" panose="02020603050405020304" pitchFamily="18" charset="0"/>
                <a:ea typeface="宋体" pitchFamily="2" charset="-122"/>
              </a:defRPr>
            </a:lvl1pPr>
          </a:lstStyle>
          <a:p>
            <a:pPr algn="ctr"/>
            <a:r>
              <a:rPr lang="en-US" altLang="zh-CN" dirty="0"/>
              <a:t>LUSC</a:t>
            </a:r>
            <a:endParaRPr lang="zh-CN" altLang="en-US" dirty="0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C321E857-EC92-4745-B609-B375334B797C}"/>
              </a:ext>
            </a:extLst>
          </p:cNvPr>
          <p:cNvSpPr/>
          <p:nvPr/>
        </p:nvSpPr>
        <p:spPr>
          <a:xfrm>
            <a:off x="207645" y="3234690"/>
            <a:ext cx="6579870" cy="102870"/>
          </a:xfrm>
          <a:prstGeom prst="rect">
            <a:avLst/>
          </a:prstGeom>
          <a:solidFill>
            <a:srgbClr val="FFFFFF">
              <a:alpha val="100000"/>
            </a:srgbClr>
          </a:solidFill>
          <a:ln w="12700" cmpd="sng">
            <a:noFill/>
            <a:prstDash val="solid"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zh-CN" altLang="en-US" sz="900">
              <a:solidFill>
                <a:srgbClr val="000000"/>
              </a:solidFill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0507FA9-6553-4F60-9A3B-871A30373996}"/>
              </a:ext>
            </a:extLst>
          </p:cNvPr>
          <p:cNvSpPr txBox="1"/>
          <p:nvPr/>
        </p:nvSpPr>
        <p:spPr>
          <a:xfrm rot="16200000">
            <a:off x="-575890" y="5826842"/>
            <a:ext cx="1336485" cy="229870"/>
          </a:xfrm>
          <a:prstGeom prst="rect">
            <a:avLst/>
          </a:prstGeom>
          <a:noFill/>
        </p:spPr>
        <p:txBody>
          <a:bodyPr wrap="square">
            <a:noAutofit/>
          </a:bodyPr>
          <a:lstStyle>
            <a:defPPr>
              <a:defRPr lang="en-US"/>
            </a:defPPr>
            <a:lvl1pPr>
              <a:defRPr sz="900" b="1" kern="0">
                <a:latin typeface="Times New Roman" panose="02020603050405020304" pitchFamily="18" charset="0"/>
                <a:ea typeface="宋体" pitchFamily="2" charset="-122"/>
              </a:defRPr>
            </a:lvl1pPr>
          </a:lstStyle>
          <a:p>
            <a:pPr algn="ctr"/>
            <a:r>
              <a:rPr lang="en-US" altLang="zh-CN" dirty="0"/>
              <a:t>LUSC</a:t>
            </a:r>
            <a:endParaRPr lang="zh-CN" altLang="en-US" dirty="0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3F03FD60-0ED7-4F19-B86A-10F185791092}"/>
              </a:ext>
            </a:extLst>
          </p:cNvPr>
          <p:cNvSpPr/>
          <p:nvPr/>
        </p:nvSpPr>
        <p:spPr>
          <a:xfrm>
            <a:off x="307105" y="3357245"/>
            <a:ext cx="3203088" cy="2311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 Macrophage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17B60B7-07A1-43B3-8C78-D7A5518FD6AE}"/>
              </a:ext>
            </a:extLst>
          </p:cNvPr>
          <p:cNvSpPr/>
          <p:nvPr/>
        </p:nvSpPr>
        <p:spPr>
          <a:xfrm>
            <a:off x="3780789" y="3357245"/>
            <a:ext cx="3229767" cy="2311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5E52D3C5-F795-4887-BEC1-4FE38657AFAC}"/>
              </a:ext>
            </a:extLst>
          </p:cNvPr>
          <p:cNvSpPr/>
          <p:nvPr/>
        </p:nvSpPr>
        <p:spPr>
          <a:xfrm>
            <a:off x="7242977" y="3357245"/>
            <a:ext cx="3202533" cy="2311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ndritic cell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BD059CB4-1EA8-445E-BC69-E7832C39B042}"/>
              </a:ext>
            </a:extLst>
          </p:cNvPr>
          <p:cNvSpPr/>
          <p:nvPr/>
        </p:nvSpPr>
        <p:spPr>
          <a:xfrm>
            <a:off x="207645" y="5024619"/>
            <a:ext cx="6579870" cy="103505"/>
          </a:xfrm>
          <a:prstGeom prst="rect">
            <a:avLst/>
          </a:prstGeom>
          <a:solidFill>
            <a:srgbClr val="FFFFFF">
              <a:alpha val="100000"/>
            </a:srgbClr>
          </a:solidFill>
          <a:ln w="12700" cmpd="sng">
            <a:noFill/>
            <a:prstDash val="solid"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zh-CN" altLang="en-US" sz="900">
              <a:solidFill>
                <a:srgbClr val="000000"/>
              </a:solidFill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953C1D30-C308-46B3-97D5-E8AA6F3241A2}"/>
              </a:ext>
            </a:extLst>
          </p:cNvPr>
          <p:cNvSpPr/>
          <p:nvPr/>
        </p:nvSpPr>
        <p:spPr>
          <a:xfrm>
            <a:off x="139065" y="6610020"/>
            <a:ext cx="6579870" cy="103505"/>
          </a:xfrm>
          <a:prstGeom prst="rect">
            <a:avLst/>
          </a:prstGeom>
          <a:solidFill>
            <a:srgbClr val="FFFFFF">
              <a:alpha val="100000"/>
            </a:srgbClr>
          </a:solidFill>
          <a:ln w="12700" cmpd="sng">
            <a:noFill/>
            <a:prstDash val="solid"/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zh-CN" altLang="en-US">
              <a:solidFill>
                <a:srgbClr val="000000"/>
              </a:solidFill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4BDEFB9-E6BE-4D53-85B3-BE4D8B033F07}"/>
              </a:ext>
            </a:extLst>
          </p:cNvPr>
          <p:cNvSpPr txBox="1"/>
          <p:nvPr/>
        </p:nvSpPr>
        <p:spPr>
          <a:xfrm>
            <a:off x="139065" y="6757815"/>
            <a:ext cx="12052935" cy="141642"/>
          </a:xfrm>
          <a:prstGeom prst="rect">
            <a:avLst/>
          </a:prstGeom>
          <a:noFill/>
        </p:spPr>
        <p:txBody>
          <a:bodyPr wrap="square" anchor="b">
            <a:spAutoFit/>
          </a:bodyPr>
          <a:lstStyle>
            <a:lvl1pPr algn="ctr">
              <a:lnSpc>
                <a:spcPts val="170"/>
              </a:lnSpc>
              <a:defRPr sz="800" b="1" kern="0">
                <a:latin typeface="Times New Roman" panose="02020603050405020304"/>
              </a:defRPr>
            </a:lvl1pPr>
          </a:lstStyle>
          <a:p>
            <a:r>
              <a:rPr lang="en-US" altLang="zh-CN" sz="1000" dirty="0"/>
              <a:t>log2(SIRT2 TPM)</a:t>
            </a:r>
            <a:endParaRPr lang="zh-CN" altLang="en-US" sz="1000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F0CF15A1-D9EA-4B69-9025-863A70C9E4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801" y="325986"/>
            <a:ext cx="1626475" cy="144000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01C6E27-3B75-447B-AB74-8CAF059D39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7324" y="328898"/>
            <a:ext cx="1488345" cy="14400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E71B6F3E-834D-4684-90D3-36EF4BE7C9A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7430" y="1888691"/>
            <a:ext cx="1633846" cy="144000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D8878A8F-BF2A-426D-A112-E444707E7CD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18270" y="1903938"/>
            <a:ext cx="1491923" cy="14400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7CD74515-83D1-43CC-A5EE-5ED6E0A4D0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33235" y="318436"/>
            <a:ext cx="1614442" cy="144000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86312009-B589-41F3-8C9F-52EFF746556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27278" y="325986"/>
            <a:ext cx="1470638" cy="1440000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83FA8841-507E-4C00-8DD0-C03E266EC2B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33235" y="1898920"/>
            <a:ext cx="1637783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158625A5-7530-4259-98B4-5BD5B7BE4D4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501342" y="1898415"/>
            <a:ext cx="1495385" cy="144000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091A38B7-2F7A-4995-9151-E8E481D86FF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139061" y="340956"/>
            <a:ext cx="1630385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B6C7F0B5-ECB2-4189-8C37-1CDD6D5DE83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71069" y="334171"/>
            <a:ext cx="1491923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42262ADB-6F4E-4F14-A1E4-B63D63548D5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150259" y="1898415"/>
            <a:ext cx="1634313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38179D76-87B4-4376-89E7-05F0F3D24CA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998124" y="1907296"/>
            <a:ext cx="1491799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2F5BE0F1-8A97-4A72-AFAA-1AC994DCBDD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27430" y="3697094"/>
            <a:ext cx="1630385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0B1C1D05-50C9-46C5-AF4A-CBFC70B1685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25534" y="3694306"/>
            <a:ext cx="1491923" cy="1440000"/>
          </a:xfrm>
          <a:prstGeom prst="rect">
            <a:avLst/>
          </a:prstGeom>
        </p:spPr>
      </p:pic>
      <p:pic>
        <p:nvPicPr>
          <p:cNvPr id="71" name="图片 70">
            <a:extLst>
              <a:ext uri="{FF2B5EF4-FFF2-40B4-BE49-F238E27FC236}">
                <a16:creationId xmlns:a16="http://schemas.microsoft.com/office/drawing/2014/main" id="{FA7E27C0-1359-4B0B-8F92-47017EEBB13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34801" y="5265136"/>
            <a:ext cx="1630385" cy="1440000"/>
          </a:xfrm>
          <a:prstGeom prst="rect">
            <a:avLst/>
          </a:prstGeom>
        </p:spPr>
      </p:pic>
      <p:pic>
        <p:nvPicPr>
          <p:cNvPr id="73" name="图片 72">
            <a:extLst>
              <a:ext uri="{FF2B5EF4-FFF2-40B4-BE49-F238E27FC236}">
                <a16:creationId xmlns:a16="http://schemas.microsoft.com/office/drawing/2014/main" id="{A23F47F0-B63C-4CAE-A5B3-53114739D2B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033728" y="5273535"/>
            <a:ext cx="1474204" cy="1440000"/>
          </a:xfrm>
          <a:prstGeom prst="rect">
            <a:avLst/>
          </a:prstGeom>
        </p:spPr>
      </p:pic>
      <p:pic>
        <p:nvPicPr>
          <p:cNvPr id="75" name="图片 74">
            <a:extLst>
              <a:ext uri="{FF2B5EF4-FFF2-40B4-BE49-F238E27FC236}">
                <a16:creationId xmlns:a16="http://schemas.microsoft.com/office/drawing/2014/main" id="{B2BD3BEE-29B6-421A-ACDE-B96A9CD9BB87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736705" y="3689859"/>
            <a:ext cx="1634313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77" name="图片 76">
            <a:extLst>
              <a:ext uri="{FF2B5EF4-FFF2-40B4-BE49-F238E27FC236}">
                <a16:creationId xmlns:a16="http://schemas.microsoft.com/office/drawing/2014/main" id="{F6207CAB-1F2E-4309-8A9F-1256A9EDD343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518301" y="3685811"/>
            <a:ext cx="1488462" cy="1440000"/>
          </a:xfrm>
          <a:prstGeom prst="rect">
            <a:avLst/>
          </a:prstGeom>
        </p:spPr>
      </p:pic>
      <p:pic>
        <p:nvPicPr>
          <p:cNvPr id="79" name="图片 78">
            <a:extLst>
              <a:ext uri="{FF2B5EF4-FFF2-40B4-BE49-F238E27FC236}">
                <a16:creationId xmlns:a16="http://schemas.microsoft.com/office/drawing/2014/main" id="{5BD1BD55-CEBF-4438-8253-610F8DEC8F07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733235" y="5273535"/>
            <a:ext cx="1637783" cy="1440000"/>
          </a:xfrm>
          <a:prstGeom prst="rect">
            <a:avLst/>
          </a:prstGeom>
        </p:spPr>
      </p:pic>
      <p:pic>
        <p:nvPicPr>
          <p:cNvPr id="81" name="图片 80">
            <a:extLst>
              <a:ext uri="{FF2B5EF4-FFF2-40B4-BE49-F238E27FC236}">
                <a16:creationId xmlns:a16="http://schemas.microsoft.com/office/drawing/2014/main" id="{2D311673-B784-43CB-9138-DF29D8D0D0FB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514840" y="5265136"/>
            <a:ext cx="1491923" cy="1440000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0F6B663C-B99F-47CF-942C-E9A930908FE1}"/>
              </a:ext>
            </a:extLst>
          </p:cNvPr>
          <p:cNvSpPr txBox="1"/>
          <p:nvPr/>
        </p:nvSpPr>
        <p:spPr>
          <a:xfrm>
            <a:off x="207329" y="1742908"/>
            <a:ext cx="106546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                                                         H                                                         I                                                            J                                                        K                                                            L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9C4FCAF-4575-42D1-95D8-5B397B884033}"/>
              </a:ext>
            </a:extLst>
          </p:cNvPr>
          <p:cNvSpPr txBox="1"/>
          <p:nvPr/>
        </p:nvSpPr>
        <p:spPr>
          <a:xfrm>
            <a:off x="173990" y="5156064"/>
            <a:ext cx="114846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                                                       T                                                            U                                                          V                                                         W                                                        X</a:t>
            </a:r>
            <a:r>
              <a: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83" name="图片 82">
            <a:extLst>
              <a:ext uri="{FF2B5EF4-FFF2-40B4-BE49-F238E27FC236}">
                <a16:creationId xmlns:a16="http://schemas.microsoft.com/office/drawing/2014/main" id="{C6804F64-0253-4A19-9B08-95400B0F7BB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7148861" y="3686138"/>
            <a:ext cx="1630385" cy="144000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85" name="图片 84">
            <a:extLst>
              <a:ext uri="{FF2B5EF4-FFF2-40B4-BE49-F238E27FC236}">
                <a16:creationId xmlns:a16="http://schemas.microsoft.com/office/drawing/2014/main" id="{886BCEE9-6B6F-4B93-A945-9A349020813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8992008" y="3676742"/>
            <a:ext cx="1495385" cy="14400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BBDD7570-AF50-4DDC-91A3-6126F211028F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9013671" y="5251315"/>
            <a:ext cx="1481045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6509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8</Words>
  <Application>Microsoft Office PowerPoint</Application>
  <PresentationFormat>宽屏</PresentationFormat>
  <Paragraphs>1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Jian</dc:creator>
  <cp:lastModifiedBy>He Jian</cp:lastModifiedBy>
  <cp:revision>50</cp:revision>
  <dcterms:created xsi:type="dcterms:W3CDTF">2022-04-20T10:32:51Z</dcterms:created>
  <dcterms:modified xsi:type="dcterms:W3CDTF">2022-04-28T17:15:20Z</dcterms:modified>
</cp:coreProperties>
</file>